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1" autoAdjust="0"/>
    <p:restoredTop sz="94660"/>
  </p:normalViewPr>
  <p:slideViewPr>
    <p:cSldViewPr snapToGrid="0">
      <p:cViewPr varScale="1">
        <p:scale>
          <a:sx n="70" d="100"/>
          <a:sy n="70" d="100"/>
        </p:scale>
        <p:origin x="6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4EE548-0F78-BDD8-2FAC-F187ED16AA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0C8204B-73B2-E53C-B425-5480BD5ACC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E3C5EC-8B65-E1A4-ED67-9E17AABB5C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012F41C-28FC-A332-4DBB-A29138A41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39F302-82C4-8F82-D73B-EE369BFF3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0950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5B9B4D4-7C61-4C92-E24B-7A47E52B5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E927042-AD98-C79F-AD1B-1646441FB21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031795-A4DD-F5E8-FA57-418C58BA27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97F760-5B37-EBF7-9C2B-F8D6DDDBD1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D3A29F-3973-912B-EAE4-866635FED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4607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11A538E-42A2-09D3-B62E-27E4038CC4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212AA9-7594-3C3A-33F7-5E09736A4D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AAECD6-1473-6087-408E-FD57F10D8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AB6068-13B6-E65A-ABAD-C23B93360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C8995F-7CC9-0E1B-EE58-715DBF9E3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1359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4F91AA4-A805-539A-D207-C68D458E1E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99781C-433B-A570-4EB0-2851D9E8CB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524060-2BC1-703E-7D0F-682C6194A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FC1C41-A782-1CD4-067C-ED1423379D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FBE955-C110-DB4F-C32B-D89EAE49D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2670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20E9B2-B9AB-3722-707E-60D159A31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1E51A9-E07D-7FA7-4929-C96ED583A8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9B79DA8-DC44-2D1A-A7B7-FA802F7B7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CCFC81-FF65-6F0C-BADD-FDF4BD4DE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5AE14B-72C9-FCEE-B52C-7D530BBEB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68909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7B17FA-2C95-89AD-10E9-A5F8173372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08D414E-4206-E05A-F7D2-19EB785D9A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CADC433-FD3F-5E3F-5C6F-D2EBE4764E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2B9BCC1-27E1-4AAA-50CA-7E47EEEDA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007B4B-E25C-8E2E-A8C2-8F95A2A344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42749B8-8E4D-FCC6-8263-1F1676671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117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82EFFB-C5CA-376D-B0F0-6EA99423B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D9C5F28-BFD0-DD5C-FCD1-0ABCD19DF0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A9CC3B0-036B-F281-A688-2357C7B0B8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0A63E63-C96F-0F49-7739-EFD4668E1C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9D0AE20-D4DA-2322-F31E-EC46FAE079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59FF36D-3E2F-DDD9-F770-DC8E7EDB6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0161D6D-6878-31DB-FCE9-DFB1B2435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DAEBDAE3-6377-7E24-E991-C228052BC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040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DAAC17-7F0E-5854-80FB-CF5235C876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3EB0069-3D9B-C1A6-7743-EE4B32EFBC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574ED9B-EEFD-8B73-0418-38C7A1E3F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C438E82-1184-86A8-3933-691DA49EC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5287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1323E0F-2AA3-4BDA-6E9A-041558666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D5182E7-755B-389A-8CD1-CA7C828596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B67649E-3044-1136-85CD-CAB018F31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6497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86DF31-75B1-8D29-7169-DFD7BBD148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6238E59-1272-D5BF-6091-C280B3EF21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5A27990-6165-13C7-CB73-5B44DF4A6C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174D443-3D20-93B7-FF33-4ACA847E0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C12F4C8-2872-F7E7-6960-BEA5CEE17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1CB3E2-9DB3-EEDB-F629-6D49CAEC65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41755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328E1C-080D-9489-7428-3A97B43200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FBB9273D-212B-E437-233C-E701160D0C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6AB2720-5D36-8AEC-C116-373DBDC1AA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7164A60-E93D-582E-55F8-ABA972504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EE4350-04DA-1E57-9DD4-68A24295E5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3E214F0-EF57-8134-AF29-B6B61EB01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51100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C1654E9C-1182-927D-090D-B963A21186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47840A6-A22B-526C-9637-C68404D96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71BABC-6572-B4BC-1BB1-B5D0C81F8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C31A1-E38C-4D5C-8E1A-B31A405311C9}" type="datetimeFigureOut">
              <a:rPr lang="zh-CN" altLang="en-US" smtClean="0"/>
              <a:t>2022/10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156E78-721E-E9B6-9CF4-F0FBF03B52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A05E125-81D6-39BA-1E10-0CFE66F94F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F6713-8A95-4E01-A94D-E9CC1E1022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92432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BF95AD6-BFBE-88E9-96E4-0D4BCD2E60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25006"/>
            <a:ext cx="12192000" cy="545502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47071F8-E95F-035C-9DF5-FBBE26F8129C}"/>
              </a:ext>
            </a:extLst>
          </p:cNvPr>
          <p:cNvSpPr txBox="1"/>
          <p:nvPr/>
        </p:nvSpPr>
        <p:spPr>
          <a:xfrm>
            <a:off x="848360" y="400595"/>
            <a:ext cx="10820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-457200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zh-CN" sz="1800" b="1" dirty="0">
                <a:effectLst/>
                <a:ea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alysis of 1500 bp cis-acting element upstream of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rKNOX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genes. Blocks of different colors represented different action elements.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4612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58421AD-27A8-1539-B7EB-5020B221C90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3640" y="1014878"/>
            <a:ext cx="9487585" cy="561452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42D5350-ECF8-4BBE-D7B5-294579FAFA6C}"/>
              </a:ext>
            </a:extLst>
          </p:cNvPr>
          <p:cNvSpPr txBox="1"/>
          <p:nvPr/>
        </p:nvSpPr>
        <p:spPr>
          <a:xfrm>
            <a:off x="848360" y="400595"/>
            <a:ext cx="10820400" cy="873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indent="-457200">
              <a:lnSpc>
                <a:spcPct val="150000"/>
              </a:lnSpc>
            </a:pP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r>
              <a:rPr lang="zh-CN" altLang="zh-CN" sz="1800" b="1" dirty="0">
                <a:effectLst/>
                <a:ea typeface="Times New Roman" panose="02020603050405020304" pitchFamily="18" charset="0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protein sequences alignment of TrKNOX5, TrKNOX9 and TrKNOX21 with their homologous protein in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. thaliana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,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M. </a:t>
            </a:r>
            <a:r>
              <a:rPr lang="en-US" altLang="zh-CN" sz="18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runcatula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d </a:t>
            </a:r>
            <a:r>
              <a:rPr lang="en-US" altLang="zh-CN" sz="18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. pratense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7896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53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an jinwan</dc:creator>
  <cp:lastModifiedBy>MDPI</cp:lastModifiedBy>
  <cp:revision>4</cp:revision>
  <dcterms:created xsi:type="dcterms:W3CDTF">2022-08-25T11:52:28Z</dcterms:created>
  <dcterms:modified xsi:type="dcterms:W3CDTF">2022-10-01T04:06:48Z</dcterms:modified>
</cp:coreProperties>
</file>